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70" r:id="rId3"/>
    <p:sldId id="258" r:id="rId4"/>
    <p:sldId id="271" r:id="rId5"/>
    <p:sldId id="273" r:id="rId6"/>
    <p:sldId id="274" r:id="rId7"/>
    <p:sldId id="278" r:id="rId8"/>
    <p:sldId id="275" r:id="rId9"/>
    <p:sldId id="279" r:id="rId10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7315" autoAdjust="0"/>
    <p:restoredTop sz="94660"/>
  </p:normalViewPr>
  <p:slideViewPr>
    <p:cSldViewPr>
      <p:cViewPr>
        <p:scale>
          <a:sx n="120" d="100"/>
          <a:sy n="120" d="100"/>
        </p:scale>
        <p:origin x="1260" y="-2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icky Hu" userId="74952a1e-9491-460f-aae8-298d66201d6b" providerId="ADAL" clId="{EB8BB59A-DE41-4F19-B3CA-B785DD19E4E3}"/>
    <pc:docChg chg="undo custSel modSld">
      <pc:chgData name="Ricky Hu" userId="74952a1e-9491-460f-aae8-298d66201d6b" providerId="ADAL" clId="{EB8BB59A-DE41-4F19-B3CA-B785DD19E4E3}" dt="2022-06-15T07:19:28.682" v="27" actId="313"/>
      <pc:docMkLst>
        <pc:docMk/>
      </pc:docMkLst>
      <pc:sldChg chg="modSp mod">
        <pc:chgData name="Ricky Hu" userId="74952a1e-9491-460f-aae8-298d66201d6b" providerId="ADAL" clId="{EB8BB59A-DE41-4F19-B3CA-B785DD19E4E3}" dt="2022-06-15T07:18:18.601" v="22" actId="20577"/>
        <pc:sldMkLst>
          <pc:docMk/>
          <pc:sldMk cId="4266667616" sldId="258"/>
        </pc:sldMkLst>
        <pc:spChg chg="mod">
          <ac:chgData name="Ricky Hu" userId="74952a1e-9491-460f-aae8-298d66201d6b" providerId="ADAL" clId="{EB8BB59A-DE41-4F19-B3CA-B785DD19E4E3}" dt="2022-06-15T07:18:18.601" v="22" actId="20577"/>
          <ac:spMkLst>
            <pc:docMk/>
            <pc:sldMk cId="4266667616" sldId="258"/>
            <ac:spMk id="6" creationId="{00000000-0000-0000-0000-000000000000}"/>
          </ac:spMkLst>
        </pc:spChg>
      </pc:sldChg>
      <pc:sldChg chg="modSp mod">
        <pc:chgData name="Ricky Hu" userId="74952a1e-9491-460f-aae8-298d66201d6b" providerId="ADAL" clId="{EB8BB59A-DE41-4F19-B3CA-B785DD19E4E3}" dt="2022-06-15T07:16:12.540" v="0" actId="20577"/>
        <pc:sldMkLst>
          <pc:docMk/>
          <pc:sldMk cId="3738441162" sldId="259"/>
        </pc:sldMkLst>
        <pc:spChg chg="mod">
          <ac:chgData name="Ricky Hu" userId="74952a1e-9491-460f-aae8-298d66201d6b" providerId="ADAL" clId="{EB8BB59A-DE41-4F19-B3CA-B785DD19E4E3}" dt="2022-06-15T07:16:12.540" v="0" actId="20577"/>
          <ac:spMkLst>
            <pc:docMk/>
            <pc:sldMk cId="3738441162" sldId="259"/>
            <ac:spMk id="5" creationId="{00000000-0000-0000-0000-000000000000}"/>
          </ac:spMkLst>
        </pc:spChg>
      </pc:sldChg>
      <pc:sldChg chg="modSp mod">
        <pc:chgData name="Ricky Hu" userId="74952a1e-9491-460f-aae8-298d66201d6b" providerId="ADAL" clId="{EB8BB59A-DE41-4F19-B3CA-B785DD19E4E3}" dt="2022-06-15T07:16:30.975" v="2" actId="20577"/>
        <pc:sldMkLst>
          <pc:docMk/>
          <pc:sldMk cId="3886065803" sldId="270"/>
        </pc:sldMkLst>
        <pc:spChg chg="mod">
          <ac:chgData name="Ricky Hu" userId="74952a1e-9491-460f-aae8-298d66201d6b" providerId="ADAL" clId="{EB8BB59A-DE41-4F19-B3CA-B785DD19E4E3}" dt="2022-06-15T07:16:30.975" v="2" actId="20577"/>
          <ac:spMkLst>
            <pc:docMk/>
            <pc:sldMk cId="3886065803" sldId="270"/>
            <ac:spMk id="20" creationId="{00000000-0000-0000-0000-000000000000}"/>
          </ac:spMkLst>
        </pc:spChg>
      </pc:sldChg>
      <pc:sldChg chg="modSp mod">
        <pc:chgData name="Ricky Hu" userId="74952a1e-9491-460f-aae8-298d66201d6b" providerId="ADAL" clId="{EB8BB59A-DE41-4F19-B3CA-B785DD19E4E3}" dt="2022-06-15T07:18:47.263" v="23" actId="20577"/>
        <pc:sldMkLst>
          <pc:docMk/>
          <pc:sldMk cId="907048468" sldId="271"/>
        </pc:sldMkLst>
        <pc:spChg chg="mod">
          <ac:chgData name="Ricky Hu" userId="74952a1e-9491-460f-aae8-298d66201d6b" providerId="ADAL" clId="{EB8BB59A-DE41-4F19-B3CA-B785DD19E4E3}" dt="2022-06-15T07:18:47.263" v="23" actId="20577"/>
          <ac:spMkLst>
            <pc:docMk/>
            <pc:sldMk cId="907048468" sldId="271"/>
            <ac:spMk id="5" creationId="{00000000-0000-0000-0000-000000000000}"/>
          </ac:spMkLst>
        </pc:spChg>
      </pc:sldChg>
      <pc:sldChg chg="modSp mod">
        <pc:chgData name="Ricky Hu" userId="74952a1e-9491-460f-aae8-298d66201d6b" providerId="ADAL" clId="{EB8BB59A-DE41-4F19-B3CA-B785DD19E4E3}" dt="2022-06-15T07:19:19.495" v="26" actId="20577"/>
        <pc:sldMkLst>
          <pc:docMk/>
          <pc:sldMk cId="158351245" sldId="278"/>
        </pc:sldMkLst>
        <pc:spChg chg="mod">
          <ac:chgData name="Ricky Hu" userId="74952a1e-9491-460f-aae8-298d66201d6b" providerId="ADAL" clId="{EB8BB59A-DE41-4F19-B3CA-B785DD19E4E3}" dt="2022-06-15T07:19:19.495" v="26" actId="20577"/>
          <ac:spMkLst>
            <pc:docMk/>
            <pc:sldMk cId="158351245" sldId="278"/>
            <ac:spMk id="2" creationId="{00000000-0000-0000-0000-000000000000}"/>
          </ac:spMkLst>
        </pc:spChg>
      </pc:sldChg>
      <pc:sldChg chg="modSp mod">
        <pc:chgData name="Ricky Hu" userId="74952a1e-9491-460f-aae8-298d66201d6b" providerId="ADAL" clId="{EB8BB59A-DE41-4F19-B3CA-B785DD19E4E3}" dt="2022-06-15T07:19:28.682" v="27" actId="313"/>
        <pc:sldMkLst>
          <pc:docMk/>
          <pc:sldMk cId="1686349634" sldId="279"/>
        </pc:sldMkLst>
        <pc:spChg chg="mod">
          <ac:chgData name="Ricky Hu" userId="74952a1e-9491-460f-aae8-298d66201d6b" providerId="ADAL" clId="{EB8BB59A-DE41-4F19-B3CA-B785DD19E4E3}" dt="2022-06-15T07:19:28.682" v="27" actId="313"/>
          <ac:spMkLst>
            <pc:docMk/>
            <pc:sldMk cId="1686349634" sldId="279"/>
            <ac:spMk id="11" creationId="{00000000-0000-0000-0000-000000000000}"/>
          </ac:spMkLst>
        </pc:spChg>
      </pc:sldChg>
    </pc:docChg>
  </pc:docChgLst>
  <pc:docChgLst>
    <pc:chgData name="Ricky Hu" userId="74952a1e-9491-460f-aae8-298d66201d6b" providerId="ADAL" clId="{6C040AF3-AE64-4F85-A5ED-7EDCFD78E122}"/>
    <pc:docChg chg="modSld sldOrd">
      <pc:chgData name="Ricky Hu" userId="74952a1e-9491-460f-aae8-298d66201d6b" providerId="ADAL" clId="{6C040AF3-AE64-4F85-A5ED-7EDCFD78E122}" dt="2022-01-20T01:49:21.170" v="91" actId="20577"/>
      <pc:docMkLst>
        <pc:docMk/>
      </pc:docMkLst>
      <pc:sldChg chg="modSp mod">
        <pc:chgData name="Ricky Hu" userId="74952a1e-9491-460f-aae8-298d66201d6b" providerId="ADAL" clId="{6C040AF3-AE64-4F85-A5ED-7EDCFD78E122}" dt="2022-01-19T01:30:21.938" v="6" actId="20577"/>
        <pc:sldMkLst>
          <pc:docMk/>
          <pc:sldMk cId="4266667616" sldId="258"/>
        </pc:sldMkLst>
        <pc:spChg chg="mod">
          <ac:chgData name="Ricky Hu" userId="74952a1e-9491-460f-aae8-298d66201d6b" providerId="ADAL" clId="{6C040AF3-AE64-4F85-A5ED-7EDCFD78E122}" dt="2022-01-19T01:30:21.938" v="6" actId="20577"/>
          <ac:spMkLst>
            <pc:docMk/>
            <pc:sldMk cId="4266667616" sldId="258"/>
            <ac:spMk id="15" creationId="{00000000-0000-0000-0000-000000000000}"/>
          </ac:spMkLst>
        </pc:spChg>
      </pc:sldChg>
      <pc:sldChg chg="modSp mod">
        <pc:chgData name="Ricky Hu" userId="74952a1e-9491-460f-aae8-298d66201d6b" providerId="ADAL" clId="{6C040AF3-AE64-4F85-A5ED-7EDCFD78E122}" dt="2022-01-19T01:31:05.273" v="35" actId="1076"/>
        <pc:sldMkLst>
          <pc:docMk/>
          <pc:sldMk cId="3738441162" sldId="259"/>
        </pc:sldMkLst>
        <pc:spChg chg="mod">
          <ac:chgData name="Ricky Hu" userId="74952a1e-9491-460f-aae8-298d66201d6b" providerId="ADAL" clId="{6C040AF3-AE64-4F85-A5ED-7EDCFD78E122}" dt="2022-01-19T01:31:05.273" v="35" actId="1076"/>
          <ac:spMkLst>
            <pc:docMk/>
            <pc:sldMk cId="3738441162" sldId="259"/>
            <ac:spMk id="5" creationId="{00000000-0000-0000-0000-000000000000}"/>
          </ac:spMkLst>
        </pc:spChg>
      </pc:sldChg>
      <pc:sldChg chg="addSp modSp mod ord">
        <pc:chgData name="Ricky Hu" userId="74952a1e-9491-460f-aae8-298d66201d6b" providerId="ADAL" clId="{6C040AF3-AE64-4F85-A5ED-7EDCFD78E122}" dt="2022-01-20T01:49:21.170" v="91" actId="20577"/>
        <pc:sldMkLst>
          <pc:docMk/>
          <pc:sldMk cId="2369222460" sldId="276"/>
        </pc:sldMkLst>
        <pc:spChg chg="add mod">
          <ac:chgData name="Ricky Hu" userId="74952a1e-9491-460f-aae8-298d66201d6b" providerId="ADAL" clId="{6C040AF3-AE64-4F85-A5ED-7EDCFD78E122}" dt="2022-01-20T01:49:21.170" v="91" actId="20577"/>
          <ac:spMkLst>
            <pc:docMk/>
            <pc:sldMk cId="2369222460" sldId="276"/>
            <ac:spMk id="19" creationId="{3CC2D8DE-5B79-4BFA-9DAC-6B1FEB0BB9B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6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6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workflow step by step2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129" y="107504"/>
            <a:ext cx="4435225" cy="8143148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224644" y="8244408"/>
            <a:ext cx="663335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Fig. S1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Workflow of a novel pan-genome analysis pipeline: </a:t>
            </a:r>
            <a:r>
              <a:rPr lang="en-AU" altLang="zh-CN" dirty="0">
                <a:latin typeface="Arial" pitchFamily="34" charset="0"/>
                <a:cs typeface="Arial" pitchFamily="34" charset="0"/>
              </a:rPr>
              <a:t>Pan-genome Construction and Population Structure Variation Calling Pipeline.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84411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/>
          <p:cNvGrpSpPr/>
          <p:nvPr/>
        </p:nvGrpSpPr>
        <p:grpSpPr>
          <a:xfrm>
            <a:off x="1" y="1547664"/>
            <a:ext cx="6597351" cy="6771224"/>
            <a:chOff x="1" y="1115617"/>
            <a:chExt cx="6597351" cy="6771224"/>
          </a:xfrm>
        </p:grpSpPr>
        <p:pic>
          <p:nvPicPr>
            <p:cNvPr id="4" name="Picture 2" descr="F:\work\泛基因组\泛基因组文章撰写\pav_直方图\pav size.png"/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56" t="26543" b="22984"/>
            <a:stretch/>
          </p:blipFill>
          <p:spPr bwMode="auto">
            <a:xfrm>
              <a:off x="385401" y="1115617"/>
              <a:ext cx="5735413" cy="3319750"/>
            </a:xfrm>
            <a:prstGeom prst="rect">
              <a:avLst/>
            </a:prstGeom>
            <a:noFill/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8748" y="4435367"/>
              <a:ext cx="5688632" cy="30660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>
              <a:off x="6156206" y="4103113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err="1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bp</a:t>
              </a:r>
              <a:endParaRPr lang="zh-CN" altLang="en-US" b="1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847038" y="7517509"/>
              <a:ext cx="17620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itchFamily="18" charset="0"/>
                  <a:ea typeface="Arial Unicode MS" pitchFamily="34" charset="-122"/>
                  <a:cs typeface="Times New Roman" pitchFamily="18" charset="0"/>
                </a:rPr>
                <a:t>Insertion length</a:t>
              </a:r>
              <a:endParaRPr lang="zh-CN" altLang="en-US" b="1" dirty="0">
                <a:latin typeface="Times New Roman" pitchFamily="18" charset="0"/>
                <a:ea typeface="Arial Unicode MS" pitchFamily="34" charset="-122"/>
                <a:cs typeface="Times New Roman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-310876" y="5425453"/>
              <a:ext cx="117498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itchFamily="18" charset="0"/>
                  <a:ea typeface="Arial Unicode MS" pitchFamily="34" charset="-122"/>
                  <a:cs typeface="Times New Roman" pitchFamily="18" charset="0"/>
                </a:rPr>
                <a:t>counts</a:t>
              </a:r>
              <a:endParaRPr lang="zh-CN" altLang="en-US" sz="2000" b="1" dirty="0">
                <a:latin typeface="Times New Roman" pitchFamily="18" charset="0"/>
                <a:ea typeface="Arial Unicode MS" pitchFamily="34" charset="-122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-387437" y="2575436"/>
              <a:ext cx="117498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itchFamily="18" charset="0"/>
                  <a:ea typeface="Arial Unicode MS" pitchFamily="34" charset="-122"/>
                  <a:cs typeface="Times New Roman" pitchFamily="18" charset="0"/>
                </a:rPr>
                <a:t>counts</a:t>
              </a:r>
              <a:endParaRPr lang="zh-CN" altLang="en-US" sz="2000" b="1" dirty="0">
                <a:latin typeface="Times New Roman" pitchFamily="18" charset="0"/>
                <a:ea typeface="Arial Unicode MS" pitchFamily="34" charset="-122"/>
                <a:cs typeface="Times New Roman" pitchFamily="18" charset="0"/>
              </a:endParaRPr>
            </a:p>
          </p:txBody>
        </p:sp>
      </p:grpSp>
      <p:grpSp>
        <p:nvGrpSpPr>
          <p:cNvPr id="11" name="组合 10"/>
          <p:cNvGrpSpPr/>
          <p:nvPr/>
        </p:nvGrpSpPr>
        <p:grpSpPr>
          <a:xfrm>
            <a:off x="2079903" y="1751319"/>
            <a:ext cx="4446933" cy="2314893"/>
            <a:chOff x="-415282" y="486311"/>
            <a:chExt cx="4446933" cy="2314893"/>
          </a:xfrm>
        </p:grpSpPr>
        <p:sp>
          <p:nvSpPr>
            <p:cNvPr id="14" name="TextBox 13"/>
            <p:cNvSpPr txBox="1"/>
            <p:nvPr/>
          </p:nvSpPr>
          <p:spPr>
            <a:xfrm>
              <a:off x="-415282" y="1546940"/>
              <a:ext cx="1183016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Promoter </a:t>
              </a:r>
            </a:p>
            <a:p>
              <a:pPr algn="ctr"/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region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5" name="组合 14"/>
            <p:cNvGrpSpPr/>
            <p:nvPr/>
          </p:nvGrpSpPr>
          <p:grpSpPr>
            <a:xfrm>
              <a:off x="613807" y="486311"/>
              <a:ext cx="2310855" cy="2314893"/>
              <a:chOff x="1436767" y="592991"/>
              <a:chExt cx="2310855" cy="2314893"/>
            </a:xfrm>
          </p:grpSpPr>
          <p:pic>
            <p:nvPicPr>
              <p:cNvPr id="16" name="Picture 2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581" t="20637" r="19435" b="24185"/>
              <a:stretch/>
            </p:blipFill>
            <p:spPr bwMode="auto">
              <a:xfrm rot="20091407">
                <a:off x="1436767" y="592991"/>
                <a:ext cx="2310855" cy="231489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2240209" y="1083734"/>
                <a:ext cx="81945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35.7%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1892300" y="1881360"/>
                <a:ext cx="81945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43.1%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779684" y="1608864"/>
                <a:ext cx="81945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21.2%</a:t>
                </a:r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>
              <a:off x="2627662" y="716013"/>
              <a:ext cx="13795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Gene region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776179" y="1474928"/>
              <a:ext cx="125547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Intergenic </a:t>
              </a:r>
            </a:p>
            <a:p>
              <a:pPr algn="ctr"/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region</a:t>
              </a:r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-27384" y="8219850"/>
            <a:ext cx="705678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Fig. S2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Characterization of insertion in pangenome construction. </a:t>
            </a:r>
            <a:r>
              <a:rPr lang="en-US" altLang="zh-CN" b="1" dirty="0">
                <a:latin typeface="Arial" pitchFamily="34" charset="0"/>
                <a:cs typeface="Arial" pitchFamily="34" charset="0"/>
              </a:rPr>
              <a:t>A,B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 Counts of insertions with different length. </a:t>
            </a:r>
            <a:r>
              <a:rPr lang="en-US" altLang="zh-CN" b="1" dirty="0">
                <a:latin typeface="Arial" pitchFamily="34" charset="0"/>
                <a:cs typeface="Arial" pitchFamily="34" charset="0"/>
              </a:rPr>
              <a:t>C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 Percentage of insertions within gene, promoter and intergenic region. 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25926" y="136296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56649" y="453516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561056" y="136296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C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60658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4936065"/>
              </p:ext>
            </p:extLst>
          </p:nvPr>
        </p:nvGraphicFramePr>
        <p:xfrm>
          <a:off x="358936" y="1955568"/>
          <a:ext cx="6125016" cy="1716498"/>
        </p:xfrm>
        <a:graphic>
          <a:graphicData uri="http://schemas.openxmlformats.org/drawingml/2006/table">
            <a:tbl>
              <a:tblPr/>
              <a:tblGrid>
                <a:gridCol w="6713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8419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9192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6338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7736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53682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366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imer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equence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hr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osition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 length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 ID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98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cf_1L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CACGCTTAGCATCCTCTTC</a:t>
                      </a:r>
                    </a:p>
                  </a:txBody>
                  <a:tcPr marL="7842" marR="7842" marT="784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hr8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773793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46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N1_Chr8_4288332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98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cf_1R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TTTTCCACGTCATCCCGTA</a:t>
                      </a:r>
                    </a:p>
                  </a:txBody>
                  <a:tcPr marL="7842" marR="7842" marT="78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774606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98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cf_2L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TTCACTTTCGTCGGAAAAA</a:t>
                      </a:r>
                    </a:p>
                  </a:txBody>
                  <a:tcPr marL="7842" marR="7842" marT="78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hr7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673090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26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N1_Chr7_3650740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98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cf_2R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AGCAAATGGGTTGTTGATG</a:t>
                      </a:r>
                    </a:p>
                  </a:txBody>
                  <a:tcPr marL="7842" marR="7842" marT="78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673854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98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cf_3L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TGCCATGCTGTTGAATCAT</a:t>
                      </a:r>
                    </a:p>
                  </a:txBody>
                  <a:tcPr marL="7842" marR="7842" marT="78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hr9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3625340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87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22_Chr9_21419309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98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cf_3R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CCTTTATCATGTCCCCTTCC</a:t>
                      </a:r>
                    </a:p>
                  </a:txBody>
                  <a:tcPr marL="7842" marR="7842" marT="78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3626220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98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cf_4L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CGGTAGTACAGTAGGAATGGT</a:t>
                      </a:r>
                    </a:p>
                  </a:txBody>
                  <a:tcPr marL="7842" marR="7842" marT="78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hr5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05534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64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umba_Chr5_5526446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366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cf_4R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TTCTGCTCCTTCCTCCCTC</a:t>
                      </a:r>
                    </a:p>
                  </a:txBody>
                  <a:tcPr marL="7842" marR="7842" marT="78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06566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7842" marR="7842" marT="7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pSp>
        <p:nvGrpSpPr>
          <p:cNvPr id="3" name="组合 2"/>
          <p:cNvGrpSpPr/>
          <p:nvPr/>
        </p:nvGrpSpPr>
        <p:grpSpPr>
          <a:xfrm>
            <a:off x="248292" y="565422"/>
            <a:ext cx="6339050" cy="1241076"/>
            <a:chOff x="863519" y="5436096"/>
            <a:chExt cx="5149139" cy="1008112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63519" y="5436096"/>
              <a:ext cx="5149139" cy="9639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1149152" y="6074876"/>
              <a:ext cx="8130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pavcf1</a:t>
              </a:r>
              <a:endParaRPr lang="zh-CN" altLang="en-US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437160" y="6074876"/>
              <a:ext cx="8130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pavcf2</a:t>
              </a:r>
              <a:endParaRPr lang="zh-CN" altLang="en-US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725168" y="6074876"/>
              <a:ext cx="8130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pavcf3</a:t>
              </a:r>
              <a:endParaRPr lang="zh-CN" altLang="en-US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013176" y="6074876"/>
              <a:ext cx="8130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pavcf4</a:t>
              </a:r>
              <a:endParaRPr lang="zh-CN" altLang="en-US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248292" y="3890492"/>
            <a:ext cx="6408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Fig. S3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PAV genotype confirmation by PCR  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26478" y="4259824"/>
            <a:ext cx="6182678" cy="4278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itchFamily="34" charset="0"/>
                <a:cs typeface="Arial" pitchFamily="34" charset="0"/>
              </a:rPr>
              <a:t>We chose the four PAV by random. The “CN1_Chr8_4288332</a:t>
            </a:r>
          </a:p>
          <a:p>
            <a:r>
              <a:rPr lang="en-US" altLang="zh-CN" sz="1600" dirty="0">
                <a:latin typeface="Arial" pitchFamily="34" charset="0"/>
                <a:cs typeface="Arial" pitchFamily="34" charset="0"/>
              </a:rPr>
              <a:t>” was a 246 </a:t>
            </a:r>
            <a:r>
              <a:rPr lang="en-US" altLang="zh-CN" sz="1600" dirty="0" err="1">
                <a:latin typeface="Arial" pitchFamily="34" charset="0"/>
                <a:cs typeface="Arial" pitchFamily="34" charset="0"/>
              </a:rPr>
              <a:t>bp</a:t>
            </a:r>
            <a:r>
              <a:rPr lang="en-US" altLang="zh-CN" sz="1600" dirty="0">
                <a:latin typeface="Arial" pitchFamily="34" charset="0"/>
                <a:cs typeface="Arial" pitchFamily="34" charset="0"/>
              </a:rPr>
              <a:t> PAV sequence which starts at 4,288,332 </a:t>
            </a:r>
            <a:r>
              <a:rPr lang="en-US" altLang="zh-CN" sz="1600" dirty="0" err="1">
                <a:latin typeface="Arial" pitchFamily="34" charset="0"/>
                <a:cs typeface="Arial" pitchFamily="34" charset="0"/>
              </a:rPr>
              <a:t>bp</a:t>
            </a:r>
            <a:r>
              <a:rPr lang="en-US" altLang="zh-CN" sz="1600" dirty="0">
                <a:latin typeface="Arial" pitchFamily="34" charset="0"/>
                <a:cs typeface="Arial" pitchFamily="34" charset="0"/>
              </a:rPr>
              <a:t> of CN1 genome Chromosome 8. The PAV was inserted into 4,774,311-4,774,557 </a:t>
            </a:r>
            <a:r>
              <a:rPr lang="en-US" altLang="zh-CN" sz="1600" dirty="0" err="1">
                <a:latin typeface="Arial" pitchFamily="34" charset="0"/>
                <a:cs typeface="Arial" pitchFamily="34" charset="0"/>
              </a:rPr>
              <a:t>bp</a:t>
            </a:r>
            <a:r>
              <a:rPr lang="en-US" altLang="zh-CN" sz="1600" dirty="0">
                <a:latin typeface="Arial" pitchFamily="34" charset="0"/>
                <a:cs typeface="Arial" pitchFamily="34" charset="0"/>
              </a:rPr>
              <a:t> region of pan-genome Chromosome 8. We designed the primers (pavcf_1L/pavcf_1R) for PCR to amplify the 4,773,793-4,774,606 </a:t>
            </a:r>
            <a:r>
              <a:rPr lang="en-US" altLang="zh-CN" sz="1600" dirty="0" err="1">
                <a:latin typeface="Arial" pitchFamily="34" charset="0"/>
                <a:cs typeface="Arial" pitchFamily="34" charset="0"/>
              </a:rPr>
              <a:t>bp</a:t>
            </a:r>
            <a:r>
              <a:rPr lang="en-US" altLang="zh-CN" sz="1600" dirty="0">
                <a:latin typeface="Arial" pitchFamily="34" charset="0"/>
                <a:cs typeface="Arial" pitchFamily="34" charset="0"/>
              </a:rPr>
              <a:t> region of pan-genome Chromosome 8 which covers the complete PAV “CN1_Chr8_4288332”. In the PAV genotype, the marker “Chr8_4774320” can represent the PAV “CN1_Chr8_4288332”. </a:t>
            </a:r>
          </a:p>
          <a:p>
            <a:r>
              <a:rPr lang="en-US" altLang="zh-CN" sz="1600" dirty="0">
                <a:latin typeface="Arial" pitchFamily="34" charset="0"/>
                <a:cs typeface="Arial" pitchFamily="34" charset="0"/>
              </a:rPr>
              <a:t>We know all accessions’ genotype of the PAV “CN1_Chr8_4288332” from the PAV genotype. We chose two accessions (IRRI2K_446, IRRI2K_654) with the PAV sequence and two accessions (IRRI2K_441, IRRI2K_509) without the PAV sequence by random to extract DNA for PCR. The result of agarose gel electrophoresis confirmed the genotype of the PAV “CN1_Chr8_4288332”. PCR with other primers was performed with similar process.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66676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5453" y="6311252"/>
            <a:ext cx="640871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Fig. S4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Characterization of Insertion detected in pan-genome constructing process. 11 accessions: The insertion detected in each iteration of pan-genome construction. More accessions: The insertion from comparing our pangenome to any other assembled genome.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5024" y="2339752"/>
            <a:ext cx="2038350" cy="2657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720" y="2339752"/>
            <a:ext cx="2038350" cy="2657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 rot="16200000">
            <a:off x="2736269" y="3268956"/>
            <a:ext cx="1813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Insertion counts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33348" y="3259058"/>
            <a:ext cx="1544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Insertion size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9800000">
            <a:off x="791100" y="4958360"/>
            <a:ext cx="1629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11 accessions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9800000">
            <a:off x="1193402" y="5016000"/>
            <a:ext cx="19159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More accessions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9800000">
            <a:off x="3537124" y="4958360"/>
            <a:ext cx="1629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11 accessions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9800000">
            <a:off x="3939426" y="5016000"/>
            <a:ext cx="19159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More accessions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70484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0280" y="569987"/>
            <a:ext cx="2552700" cy="3209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9723" y="3615361"/>
            <a:ext cx="3345545" cy="208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9727" y="1362030"/>
            <a:ext cx="3345546" cy="208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60648" y="53955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03246" y="348158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465004" y="72421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C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323779" y="324602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D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58100" y="6588224"/>
            <a:ext cx="656324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Fig. S5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Population resequencing analysis with pan-genome. </a:t>
            </a:r>
            <a:r>
              <a:rPr lang="en-US" altLang="zh-CN" b="1" dirty="0">
                <a:latin typeface="Arial" pitchFamily="34" charset="0"/>
                <a:cs typeface="Arial" pitchFamily="34" charset="0"/>
              </a:rPr>
              <a:t>A</a:t>
            </a:r>
          </a:p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The comparisons of Mapping rate of mapping 413 international rice accessions to Nip genome and pan-genome. </a:t>
            </a:r>
            <a:r>
              <a:rPr lang="en-US" altLang="zh-CN" b="1" dirty="0">
                <a:latin typeface="Arial" pitchFamily="34" charset="0"/>
                <a:cs typeface="Arial" pitchFamily="34" charset="0"/>
              </a:rPr>
              <a:t>B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 Pan-genome modelling. </a:t>
            </a:r>
            <a:r>
              <a:rPr lang="en-US" altLang="zh-CN" b="1" dirty="0">
                <a:latin typeface="Arial" pitchFamily="34" charset="0"/>
                <a:cs typeface="Arial" pitchFamily="34" charset="0"/>
              </a:rPr>
              <a:t>C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 The number of PAVs re-called in population with pan-genome. </a:t>
            </a:r>
            <a:r>
              <a:rPr lang="en-US" altLang="zh-CN" b="1" dirty="0">
                <a:latin typeface="Arial" pitchFamily="34" charset="0"/>
                <a:cs typeface="Arial" pitchFamily="34" charset="0"/>
              </a:rPr>
              <a:t>D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 PAV total length called in population with pan-genome.</a:t>
            </a:r>
          </a:p>
          <a:p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8" name="Picture 4" descr="F:\work\坚果同步\rice_pangenome\初稿\Figure\FigS4B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5772" y="3931762"/>
            <a:ext cx="2461180" cy="17923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222971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22324" y="7666672"/>
            <a:ext cx="6552728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altLang="zh-CN" b="1" dirty="0"/>
              <a:t>Fig. </a:t>
            </a:r>
            <a:r>
              <a:rPr lang="en-AU" altLang="zh-CN" b="1" dirty="0" err="1"/>
              <a:t>S6</a:t>
            </a:r>
            <a:r>
              <a:rPr lang="en-AU" altLang="zh-CN" b="1" dirty="0"/>
              <a:t> </a:t>
            </a:r>
            <a:r>
              <a:rPr lang="en-AU" altLang="zh-CN" dirty="0"/>
              <a:t>Whole genome </a:t>
            </a:r>
            <a:r>
              <a:rPr lang="en-AU" altLang="zh-CN" dirty="0" err="1"/>
              <a:t>FST</a:t>
            </a:r>
            <a:r>
              <a:rPr lang="en-AU" altLang="zh-CN" dirty="0"/>
              <a:t> analysis among three sub-population based on PAV and SNP. A, </a:t>
            </a:r>
            <a:r>
              <a:rPr lang="en-AU" altLang="zh-CN" dirty="0" err="1"/>
              <a:t>FST</a:t>
            </a:r>
            <a:r>
              <a:rPr lang="en-AU" altLang="zh-CN" dirty="0"/>
              <a:t> analysis between </a:t>
            </a:r>
            <a:r>
              <a:rPr lang="en-AU" altLang="zh-CN" i="1" dirty="0"/>
              <a:t>Japonica</a:t>
            </a:r>
            <a:r>
              <a:rPr lang="en-AU" altLang="zh-CN" dirty="0"/>
              <a:t> and </a:t>
            </a:r>
            <a:r>
              <a:rPr lang="en-AU" altLang="zh-CN" i="1" dirty="0" err="1"/>
              <a:t>Aus</a:t>
            </a:r>
            <a:r>
              <a:rPr lang="en-AU" altLang="zh-CN" dirty="0"/>
              <a:t>; B, </a:t>
            </a:r>
            <a:r>
              <a:rPr lang="en-AU" altLang="zh-CN" dirty="0" err="1"/>
              <a:t>FST</a:t>
            </a:r>
            <a:r>
              <a:rPr lang="en-AU" altLang="zh-CN" dirty="0"/>
              <a:t> analysis between </a:t>
            </a:r>
            <a:r>
              <a:rPr lang="en-AU" altLang="zh-CN" i="1" dirty="0"/>
              <a:t>Japonica</a:t>
            </a:r>
            <a:r>
              <a:rPr lang="en-AU" altLang="zh-CN" dirty="0"/>
              <a:t> and </a:t>
            </a:r>
            <a:r>
              <a:rPr lang="en-AU" altLang="zh-CN" i="1" dirty="0"/>
              <a:t>Indica</a:t>
            </a:r>
            <a:r>
              <a:rPr lang="en-AU" altLang="zh-CN" dirty="0"/>
              <a:t>; C, </a:t>
            </a:r>
            <a:r>
              <a:rPr lang="en-AU" altLang="zh-CN" dirty="0" err="1"/>
              <a:t>FST</a:t>
            </a:r>
            <a:r>
              <a:rPr lang="en-AU" altLang="zh-CN" dirty="0"/>
              <a:t> analysis between </a:t>
            </a:r>
            <a:r>
              <a:rPr lang="en-AU" altLang="zh-CN" i="1" dirty="0" err="1"/>
              <a:t>Aus</a:t>
            </a:r>
            <a:r>
              <a:rPr lang="en-AU" altLang="zh-CN" dirty="0"/>
              <a:t> and </a:t>
            </a:r>
            <a:r>
              <a:rPr lang="en-AU" altLang="zh-CN" i="1" dirty="0"/>
              <a:t>Indica</a:t>
            </a:r>
            <a:r>
              <a:rPr lang="en-AU" altLang="zh-CN" dirty="0"/>
              <a:t>. The red line indicate the </a:t>
            </a:r>
            <a:r>
              <a:rPr lang="en-AU" altLang="zh-CN" dirty="0" err="1"/>
              <a:t>FST</a:t>
            </a:r>
            <a:r>
              <a:rPr lang="en-AU" altLang="zh-CN" dirty="0"/>
              <a:t> value calculated by PAV, the blue line indicate the </a:t>
            </a:r>
            <a:r>
              <a:rPr lang="en-AU" altLang="zh-CN" dirty="0" err="1"/>
              <a:t>FST</a:t>
            </a:r>
            <a:r>
              <a:rPr lang="en-AU" altLang="zh-CN" dirty="0"/>
              <a:t> value calculated by SNP.</a:t>
            </a:r>
            <a:r>
              <a:rPr lang="en-AU" altLang="zh-CN" i="1" dirty="0"/>
              <a:t> </a:t>
            </a:r>
            <a:endParaRPr lang="zh-CN" altLang="zh-CN" i="1" dirty="0"/>
          </a:p>
        </p:txBody>
      </p:sp>
      <p:grpSp>
        <p:nvGrpSpPr>
          <p:cNvPr id="8" name="组合 7"/>
          <p:cNvGrpSpPr/>
          <p:nvPr/>
        </p:nvGrpSpPr>
        <p:grpSpPr>
          <a:xfrm>
            <a:off x="1014818" y="49929"/>
            <a:ext cx="4967740" cy="7546407"/>
            <a:chOff x="1131044" y="98212"/>
            <a:chExt cx="4967740" cy="7647078"/>
          </a:xfrm>
        </p:grpSpPr>
        <p:sp>
          <p:nvSpPr>
            <p:cNvPr id="6" name="TextBox 5"/>
            <p:cNvSpPr txBox="1"/>
            <p:nvPr/>
          </p:nvSpPr>
          <p:spPr>
            <a:xfrm>
              <a:off x="1218238" y="98212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itchFamily="34" charset="0"/>
                  <a:cs typeface="Arial" pitchFamily="34" charset="0"/>
                </a:rPr>
                <a:t>A</a:t>
              </a:r>
              <a:endParaRPr lang="zh-CN" alt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218238" y="2689449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itchFamily="34" charset="0"/>
                  <a:cs typeface="Arial" pitchFamily="34" charset="0"/>
                </a:rPr>
                <a:t>B</a:t>
              </a:r>
              <a:endParaRPr lang="zh-CN" altLang="en-US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" name="组合 4"/>
            <p:cNvGrpSpPr/>
            <p:nvPr/>
          </p:nvGrpSpPr>
          <p:grpSpPr>
            <a:xfrm>
              <a:off x="1131044" y="467544"/>
              <a:ext cx="4967740" cy="7277746"/>
              <a:chOff x="741359" y="390598"/>
              <a:chExt cx="5541766" cy="8184442"/>
            </a:xfrm>
          </p:grpSpPr>
          <p:pic>
            <p:nvPicPr>
              <p:cNvPr id="4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41359" y="390598"/>
                <a:ext cx="5541766" cy="23805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41359" y="3305777"/>
                <a:ext cx="5541766" cy="241435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38628" y="6153707"/>
                <a:ext cx="5444497" cy="242133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10" name="TextBox 9"/>
            <p:cNvSpPr txBox="1"/>
            <p:nvPr/>
          </p:nvSpPr>
          <p:spPr>
            <a:xfrm>
              <a:off x="1218238" y="5219319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itchFamily="34" charset="0"/>
                  <a:cs typeface="Arial" pitchFamily="34" charset="0"/>
                </a:rPr>
                <a:t>C</a:t>
              </a:r>
              <a:endParaRPr lang="zh-CN" altLang="en-US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241331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D248F7C8-1B72-4A63-8965-D45DE952266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 bwMode="auto">
          <a:xfrm>
            <a:off x="548680" y="2771800"/>
            <a:ext cx="5153025" cy="26146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36860" y="5956270"/>
            <a:ext cx="6408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Fig. S7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Phylogenetic tree constructed by PAV and  SNP data.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908720" y="3034814"/>
            <a:ext cx="50045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SNP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125452" y="3054578"/>
            <a:ext cx="46961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PAV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374280" y="2757813"/>
            <a:ext cx="44916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itchFamily="34" charset="0"/>
                <a:cs typeface="Arial" pitchFamily="34" charset="0"/>
              </a:rPr>
              <a:t>Aus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994520" y="2757813"/>
            <a:ext cx="59343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itchFamily="34" charset="0"/>
                <a:cs typeface="Arial" pitchFamily="34" charset="0"/>
              </a:rPr>
              <a:t>Indica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761482" y="2757812"/>
            <a:ext cx="79701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Japonica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3512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work\坚果同步\rice_pangenome\初稿\Figure\Figure S8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24" y="395536"/>
            <a:ext cx="6765925" cy="6673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2564904" y="3955286"/>
            <a:ext cx="2202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Plant Height GWAS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285256" y="47448"/>
            <a:ext cx="2779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1000-grain weight GWAS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754436" y="7452319"/>
            <a:ext cx="558685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Fig. S8 </a:t>
            </a:r>
            <a:r>
              <a:rPr lang="en-AU" altLang="zh-CN" dirty="0">
                <a:latin typeface="Arial" pitchFamily="34" charset="0"/>
                <a:cs typeface="Arial" pitchFamily="34" charset="0"/>
              </a:rPr>
              <a:t>GWAS in 413 accessions population. </a:t>
            </a:r>
            <a:r>
              <a:rPr lang="en-AU" altLang="zh-CN" b="1" dirty="0">
                <a:latin typeface="Arial" pitchFamily="34" charset="0"/>
                <a:cs typeface="Arial" pitchFamily="34" charset="0"/>
              </a:rPr>
              <a:t>A</a:t>
            </a:r>
            <a:r>
              <a:rPr lang="en-AU" altLang="zh-CN" dirty="0">
                <a:latin typeface="Arial" pitchFamily="34" charset="0"/>
                <a:cs typeface="Arial" pitchFamily="34" charset="0"/>
              </a:rPr>
              <a:t> Manhattan plots for thousand grain weight analysed by SNP-GWAS and PAV-GWAS. </a:t>
            </a:r>
            <a:r>
              <a:rPr lang="en-AU" altLang="zh-CN" b="1" dirty="0">
                <a:latin typeface="Arial" pitchFamily="34" charset="0"/>
                <a:cs typeface="Arial" pitchFamily="34" charset="0"/>
              </a:rPr>
              <a:t>B</a:t>
            </a:r>
            <a:r>
              <a:rPr lang="en-AU" altLang="zh-CN" dirty="0">
                <a:latin typeface="Arial" pitchFamily="34" charset="0"/>
                <a:cs typeface="Arial" pitchFamily="34" charset="0"/>
              </a:rPr>
              <a:t> Manhattan plots for plant height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73763" y="4744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76672" y="3955286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37963" y="37556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121947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704" y="395536"/>
            <a:ext cx="5314950" cy="2390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 descr="F:\work\坚果同步\rice_pangenome\初稿\Figure\GWAS_chr1_sd1\chr1 sd 局部关联 10vs10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6491" y="2987824"/>
            <a:ext cx="4996805" cy="43204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矩形 6"/>
          <p:cNvSpPr/>
          <p:nvPr/>
        </p:nvSpPr>
        <p:spPr>
          <a:xfrm>
            <a:off x="2675012" y="467544"/>
            <a:ext cx="64771" cy="1853314"/>
          </a:xfrm>
          <a:prstGeom prst="rect">
            <a:avLst/>
          </a:prstGeom>
          <a:solidFill>
            <a:schemeClr val="accent1">
              <a:lumMod val="60000"/>
              <a:lumOff val="40000"/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" name="直接连接符 4"/>
          <p:cNvCxnSpPr/>
          <p:nvPr/>
        </p:nvCxnSpPr>
        <p:spPr>
          <a:xfrm>
            <a:off x="2707397" y="2320858"/>
            <a:ext cx="0" cy="954998"/>
          </a:xfrm>
          <a:prstGeom prst="line">
            <a:avLst/>
          </a:prstGeom>
          <a:ln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矩形 10"/>
          <p:cNvSpPr/>
          <p:nvPr/>
        </p:nvSpPr>
        <p:spPr>
          <a:xfrm>
            <a:off x="528224" y="7631176"/>
            <a:ext cx="6069128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Fig. S9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Plant height PAV-GWAS identified </a:t>
            </a:r>
            <a:r>
              <a:rPr lang="en-US" altLang="zh-CN" i="1" dirty="0">
                <a:latin typeface="Arial" pitchFamily="34" charset="0"/>
                <a:cs typeface="Arial" pitchFamily="34" charset="0"/>
              </a:rPr>
              <a:t>sd1</a:t>
            </a:r>
            <a:r>
              <a:rPr lang="en-AU" altLang="zh-CN" dirty="0">
                <a:latin typeface="Arial" pitchFamily="34" charset="0"/>
                <a:cs typeface="Arial" pitchFamily="34" charset="0"/>
              </a:rPr>
              <a:t> gene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zh-CN" b="1" dirty="0">
                <a:latin typeface="Arial" pitchFamily="34" charset="0"/>
                <a:cs typeface="Arial" pitchFamily="34" charset="0"/>
              </a:rPr>
              <a:t>A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 </a:t>
            </a:r>
            <a:r>
              <a:rPr lang="en-AU" altLang="zh-CN" dirty="0">
                <a:latin typeface="Arial" pitchFamily="34" charset="0"/>
                <a:cs typeface="Arial" pitchFamily="34" charset="0"/>
              </a:rPr>
              <a:t>Local Manhattan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plot </a:t>
            </a:r>
            <a:r>
              <a:rPr lang="en-AU" altLang="zh-CN" dirty="0">
                <a:latin typeface="Arial" pitchFamily="34" charset="0"/>
                <a:cs typeface="Arial" pitchFamily="34" charset="0"/>
              </a:rPr>
              <a:t>of plant height in chromosome 1. </a:t>
            </a:r>
            <a:r>
              <a:rPr lang="en-AU" altLang="zh-CN" b="1" dirty="0">
                <a:latin typeface="Arial" pitchFamily="34" charset="0"/>
                <a:cs typeface="Arial" pitchFamily="34" charset="0"/>
              </a:rPr>
              <a:t>B</a:t>
            </a:r>
            <a:r>
              <a:rPr lang="en-AU" altLang="zh-CN" dirty="0">
                <a:latin typeface="Arial" pitchFamily="34" charset="0"/>
                <a:cs typeface="Arial" pitchFamily="34" charset="0"/>
              </a:rPr>
              <a:t> IGV (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Integrative Genomics Viewer</a:t>
            </a:r>
            <a:r>
              <a:rPr lang="en-AU" altLang="zh-CN" dirty="0">
                <a:latin typeface="Arial" pitchFamily="34" charset="0"/>
                <a:cs typeface="Arial" pitchFamily="34" charset="0"/>
              </a:rPr>
              <a:t>) showed </a:t>
            </a:r>
            <a:r>
              <a:rPr lang="en-AU" altLang="zh-CN" i="1" dirty="0">
                <a:latin typeface="Arial" pitchFamily="34" charset="0"/>
                <a:cs typeface="Arial" pitchFamily="34" charset="0"/>
              </a:rPr>
              <a:t>sd1 </a:t>
            </a:r>
            <a:r>
              <a:rPr lang="en-AU" altLang="zh-CN" dirty="0">
                <a:latin typeface="Arial" pitchFamily="34" charset="0"/>
                <a:cs typeface="Arial" pitchFamily="34" charset="0"/>
              </a:rPr>
              <a:t>structure visualization in 8 high plant height accessions and 8 low plant height accessions 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based on the DNA re-sequencing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717032" y="7236296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itchFamily="34" charset="0"/>
                <a:cs typeface="Arial" pitchFamily="34" charset="0"/>
              </a:rPr>
              <a:t>sd1</a:t>
            </a:r>
            <a:endParaRPr lang="zh-CN" altLang="en-US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" name="Picture 11" descr="F:\work\坚果同步\rice_pangenome\初稿\Figure\GWAS_chr5_1000_GW5\gwas图例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73216" y="539592"/>
            <a:ext cx="518939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811838" y="4744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76038" y="262778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左大括号 1"/>
          <p:cNvSpPr/>
          <p:nvPr/>
        </p:nvSpPr>
        <p:spPr>
          <a:xfrm>
            <a:off x="1088944" y="3468434"/>
            <a:ext cx="179816" cy="1800200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左大括号 11"/>
          <p:cNvSpPr/>
          <p:nvPr/>
        </p:nvSpPr>
        <p:spPr>
          <a:xfrm>
            <a:off x="1088944" y="5292080"/>
            <a:ext cx="179816" cy="1800200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TextBox 2"/>
          <p:cNvSpPr txBox="1"/>
          <p:nvPr/>
        </p:nvSpPr>
        <p:spPr>
          <a:xfrm rot="16200000">
            <a:off x="320003" y="4127299"/>
            <a:ext cx="1157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High plants</a:t>
            </a:r>
          </a:p>
        </p:txBody>
      </p:sp>
      <p:sp>
        <p:nvSpPr>
          <p:cNvPr id="14" name="TextBox 13"/>
          <p:cNvSpPr txBox="1"/>
          <p:nvPr/>
        </p:nvSpPr>
        <p:spPr>
          <a:xfrm rot="16200000">
            <a:off x="340040" y="5947536"/>
            <a:ext cx="11176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Low plants</a:t>
            </a:r>
          </a:p>
        </p:txBody>
      </p:sp>
    </p:spTree>
    <p:extLst>
      <p:ext uri="{BB962C8B-B14F-4D97-AF65-F5344CB8AC3E}">
        <p14:creationId xmlns:p14="http://schemas.microsoft.com/office/powerpoint/2010/main" val="16863496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07</TotalTime>
  <Words>625</Words>
  <Application>Microsoft Office PowerPoint</Application>
  <PresentationFormat>On-screen Show (4:3)</PresentationFormat>
  <Paragraphs>104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 Unicode MS</vt:lpstr>
      <vt:lpstr>Arial</vt:lpstr>
      <vt:lpstr>Calibri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Ricky Hu</cp:lastModifiedBy>
  <cp:revision>161</cp:revision>
  <dcterms:created xsi:type="dcterms:W3CDTF">2021-11-16T01:08:00Z</dcterms:created>
  <dcterms:modified xsi:type="dcterms:W3CDTF">2022-06-15T07:19:33Z</dcterms:modified>
</cp:coreProperties>
</file>